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2143080" y="685440"/>
            <a:ext cx="257184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CA1A65-3542-411E-8A1D-0F69156D4408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PlaceHolder 1"/>
          <p:cNvSpPr>
            <a:spLocks noGrp="1"/>
          </p:cNvSpPr>
          <p:nvPr>
            <p:ph type="sldImg"/>
          </p:nvPr>
        </p:nvSpPr>
        <p:spPr>
          <a:xfrm>
            <a:off x="2143080" y="685800"/>
            <a:ext cx="2571840" cy="3429000"/>
          </a:xfrm>
          <a:prstGeom prst="rect">
            <a:avLst/>
          </a:prstGeom>
          <a:ln w="0">
            <a:noFill/>
          </a:ln>
        </p:spPr>
      </p:sp>
      <p:sp>
        <p:nvSpPr>
          <p:cNvPr id="11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zh-CN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8" name="幻灯片编号占位符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DE6B34A-81A2-44D6-BF3E-831071519959}" type="slidenum">
              <a:rPr b="0" lang="zh-CN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617EDD2-EDF8-40F4-A60C-3F5064E1D93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03DAD9-4909-4C7F-883A-2065ACBC36A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BC869-CFE4-4F35-982B-0D50521C59A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90B059-3584-40B2-AB64-70D575E758A2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F88C3-F7D1-496A-905B-EFE41221409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8CB5905-CB58-4301-815B-E81B18BF00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60A0DE-B119-48FD-8A10-D1E62EECB9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639C4-B62D-4C2C-B06B-C0ADCF27D0A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2F8CB0-AE68-440A-851A-4835DD4362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C446505-34BD-403E-A3A6-F6B5D485B4B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93AD19-E198-4FBA-AD06-26A2D018261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56F775-5003-4916-B754-85C7A88D9C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6E7F216-D90F-4BC5-843F-6976533C3023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组合 73"/>
          <p:cNvGrpSpPr/>
          <p:nvPr/>
        </p:nvGrpSpPr>
        <p:grpSpPr>
          <a:xfrm>
            <a:off x="295200" y="928800"/>
            <a:ext cx="5531760" cy="5538960"/>
            <a:chOff x="295200" y="928800"/>
            <a:chExt cx="5531760" cy="5538960"/>
          </a:xfrm>
        </p:grpSpPr>
        <p:sp>
          <p:nvSpPr>
            <p:cNvPr id="49" name="Line 36"/>
            <p:cNvSpPr/>
            <p:nvPr/>
          </p:nvSpPr>
          <p:spPr>
            <a:xfrm>
              <a:off x="399960" y="4330800"/>
              <a:ext cx="539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Line 37"/>
            <p:cNvSpPr/>
            <p:nvPr/>
          </p:nvSpPr>
          <p:spPr>
            <a:xfrm>
              <a:off x="406080" y="6451920"/>
              <a:ext cx="539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Line 38"/>
            <p:cNvSpPr/>
            <p:nvPr/>
          </p:nvSpPr>
          <p:spPr>
            <a:xfrm>
              <a:off x="406080" y="4041720"/>
              <a:ext cx="539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39"/>
            <p:cNvSpPr/>
            <p:nvPr/>
          </p:nvSpPr>
          <p:spPr>
            <a:xfrm>
              <a:off x="1985040" y="4069080"/>
              <a:ext cx="1108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Forward prim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Rectangle 40"/>
            <p:cNvSpPr/>
            <p:nvPr/>
          </p:nvSpPr>
          <p:spPr>
            <a:xfrm>
              <a:off x="4174560" y="4069080"/>
              <a:ext cx="1099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Reverse primer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Rectangle 41"/>
            <p:cNvSpPr/>
            <p:nvPr/>
          </p:nvSpPr>
          <p:spPr>
            <a:xfrm>
              <a:off x="387000" y="4317840"/>
              <a:ext cx="79956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β-cateni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(BC058926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42"/>
            <p:cNvSpPr/>
            <p:nvPr/>
          </p:nvSpPr>
          <p:spPr>
            <a:xfrm>
              <a:off x="1464120" y="4386240"/>
              <a:ext cx="21816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TTACGACAGACTGCCTTCAAAT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Rectangle 43"/>
            <p:cNvSpPr/>
            <p:nvPr/>
          </p:nvSpPr>
          <p:spPr>
            <a:xfrm>
              <a:off x="3663000" y="4386240"/>
              <a:ext cx="2145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TTCCATCCCTTCCTGTTTAGTT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Rectangle 44"/>
            <p:cNvSpPr/>
            <p:nvPr/>
          </p:nvSpPr>
          <p:spPr>
            <a:xfrm>
              <a:off x="389880" y="4603680"/>
              <a:ext cx="831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β-catenin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(BC048153 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45"/>
            <p:cNvSpPr/>
            <p:nvPr/>
          </p:nvSpPr>
          <p:spPr>
            <a:xfrm>
              <a:off x="1475280" y="4680000"/>
              <a:ext cx="19195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GCAGCAGCAGTTTGTGGA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Rectangle 46"/>
            <p:cNvSpPr/>
            <p:nvPr/>
          </p:nvSpPr>
          <p:spPr>
            <a:xfrm>
              <a:off x="3672720" y="4680000"/>
              <a:ext cx="2154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TGTGGAGAGCTCCAGTACACC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47"/>
            <p:cNvSpPr/>
            <p:nvPr/>
          </p:nvSpPr>
          <p:spPr>
            <a:xfrm>
              <a:off x="383760" y="4889520"/>
              <a:ext cx="88560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AP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(BC0651750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Rectangle 48"/>
            <p:cNvSpPr/>
            <p:nvPr/>
          </p:nvSpPr>
          <p:spPr>
            <a:xfrm>
              <a:off x="1476000" y="4965840"/>
              <a:ext cx="21301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AACAACCTGACTGACCCTTCG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Rectangle 49"/>
            <p:cNvSpPr/>
            <p:nvPr/>
          </p:nvSpPr>
          <p:spPr>
            <a:xfrm>
              <a:off x="3664800" y="4965840"/>
              <a:ext cx="2078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ATGGGAGCCAGACCAAAGAT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50"/>
            <p:cNvSpPr/>
            <p:nvPr/>
          </p:nvSpPr>
          <p:spPr>
            <a:xfrm>
              <a:off x="388080" y="5185080"/>
              <a:ext cx="10738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RunX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(NM_001146038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Rectangle 51"/>
            <p:cNvSpPr/>
            <p:nvPr/>
          </p:nvSpPr>
          <p:spPr>
            <a:xfrm>
              <a:off x="1475280" y="5261040"/>
              <a:ext cx="20476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GTCCCAACTTCCTGTGCTCC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52"/>
            <p:cNvSpPr/>
            <p:nvPr/>
          </p:nvSpPr>
          <p:spPr>
            <a:xfrm>
              <a:off x="3674880" y="5261040"/>
              <a:ext cx="189540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TCTTGCCTCGTCCGCTCC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Rectangle 53"/>
            <p:cNvSpPr/>
            <p:nvPr/>
          </p:nvSpPr>
          <p:spPr>
            <a:xfrm>
              <a:off x="389880" y="5494680"/>
              <a:ext cx="78732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OSX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(AF184902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54"/>
            <p:cNvSpPr/>
            <p:nvPr/>
          </p:nvSpPr>
          <p:spPr>
            <a:xfrm>
              <a:off x="1470600" y="5570640"/>
              <a:ext cx="1971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ATGGCGTCCTCTCTGCTTG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Rectangle 55"/>
            <p:cNvSpPr/>
            <p:nvPr/>
          </p:nvSpPr>
          <p:spPr>
            <a:xfrm>
              <a:off x="3664800" y="5570640"/>
              <a:ext cx="2135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TGAAAGGTCAGCGTATGGCTT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Rectangle 56"/>
            <p:cNvSpPr/>
            <p:nvPr/>
          </p:nvSpPr>
          <p:spPr>
            <a:xfrm>
              <a:off x="388080" y="5804280"/>
              <a:ext cx="881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Lef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(NM_010703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57"/>
            <p:cNvSpPr/>
            <p:nvPr/>
          </p:nvSpPr>
          <p:spPr>
            <a:xfrm>
              <a:off x="1479240" y="5880240"/>
              <a:ext cx="20674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CCCTCCTACTCCAGTTACTCT-3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Rectangle 58"/>
            <p:cNvSpPr/>
            <p:nvPr/>
          </p:nvSpPr>
          <p:spPr>
            <a:xfrm>
              <a:off x="3675240" y="5880240"/>
              <a:ext cx="1997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CCACGGGCACTTTATTTGAT-3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Rectangle 59"/>
            <p:cNvSpPr/>
            <p:nvPr/>
          </p:nvSpPr>
          <p:spPr>
            <a:xfrm>
              <a:off x="388080" y="6099480"/>
              <a:ext cx="881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Dkk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(NM_010051)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Rectangle 60"/>
            <p:cNvSpPr/>
            <p:nvPr/>
          </p:nvSpPr>
          <p:spPr>
            <a:xfrm>
              <a:off x="1474560" y="6166080"/>
              <a:ext cx="20170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TTTGCCTGTTTGCGTCCTTC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Rectangle 61"/>
            <p:cNvSpPr/>
            <p:nvPr/>
          </p:nvSpPr>
          <p:spPr>
            <a:xfrm>
              <a:off x="3670200" y="6166080"/>
              <a:ext cx="18770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TACTTGTTCCCGCCCTCA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Line 66"/>
            <p:cNvSpPr/>
            <p:nvPr/>
          </p:nvSpPr>
          <p:spPr>
            <a:xfrm>
              <a:off x="406080" y="4041720"/>
              <a:ext cx="0" cy="240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Line 66"/>
            <p:cNvSpPr/>
            <p:nvPr/>
          </p:nvSpPr>
          <p:spPr>
            <a:xfrm>
              <a:off x="1447560" y="4041720"/>
              <a:ext cx="0" cy="240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Rectangle 67"/>
            <p:cNvSpPr/>
            <p:nvPr/>
          </p:nvSpPr>
          <p:spPr>
            <a:xfrm>
              <a:off x="675720" y="4068720"/>
              <a:ext cx="499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ene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Line 36"/>
            <p:cNvSpPr/>
            <p:nvPr/>
          </p:nvSpPr>
          <p:spPr>
            <a:xfrm>
              <a:off x="399960" y="4657680"/>
              <a:ext cx="539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Line 36"/>
            <p:cNvSpPr/>
            <p:nvPr/>
          </p:nvSpPr>
          <p:spPr>
            <a:xfrm>
              <a:off x="399960" y="4946760"/>
              <a:ext cx="539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36"/>
            <p:cNvSpPr/>
            <p:nvPr/>
          </p:nvSpPr>
          <p:spPr>
            <a:xfrm>
              <a:off x="399960" y="5235840"/>
              <a:ext cx="539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36"/>
            <p:cNvSpPr/>
            <p:nvPr/>
          </p:nvSpPr>
          <p:spPr>
            <a:xfrm>
              <a:off x="399960" y="5537520"/>
              <a:ext cx="539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36"/>
            <p:cNvSpPr/>
            <p:nvPr/>
          </p:nvSpPr>
          <p:spPr>
            <a:xfrm>
              <a:off x="399960" y="5839200"/>
              <a:ext cx="539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36"/>
            <p:cNvSpPr/>
            <p:nvPr/>
          </p:nvSpPr>
          <p:spPr>
            <a:xfrm>
              <a:off x="399960" y="6140880"/>
              <a:ext cx="539964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66"/>
            <p:cNvSpPr/>
            <p:nvPr/>
          </p:nvSpPr>
          <p:spPr>
            <a:xfrm>
              <a:off x="5813280" y="4041720"/>
              <a:ext cx="0" cy="240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66"/>
            <p:cNvSpPr/>
            <p:nvPr/>
          </p:nvSpPr>
          <p:spPr>
            <a:xfrm>
              <a:off x="3644640" y="4054320"/>
              <a:ext cx="0" cy="240984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Line 64"/>
            <p:cNvSpPr/>
            <p:nvPr/>
          </p:nvSpPr>
          <p:spPr>
            <a:xfrm>
              <a:off x="390240" y="1507680"/>
              <a:ext cx="327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Line 65"/>
            <p:cNvSpPr/>
            <p:nvPr/>
          </p:nvSpPr>
          <p:spPr>
            <a:xfrm>
              <a:off x="396720" y="3058200"/>
              <a:ext cx="3258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67"/>
            <p:cNvSpPr/>
            <p:nvPr/>
          </p:nvSpPr>
          <p:spPr>
            <a:xfrm>
              <a:off x="370440" y="1515600"/>
              <a:ext cx="3772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NC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Rectangle 68"/>
            <p:cNvSpPr/>
            <p:nvPr/>
          </p:nvSpPr>
          <p:spPr>
            <a:xfrm>
              <a:off x="390600" y="1730520"/>
              <a:ext cx="77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PKG1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146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69"/>
            <p:cNvSpPr/>
            <p:nvPr/>
          </p:nvSpPr>
          <p:spPr>
            <a:xfrm>
              <a:off x="393840" y="1945080"/>
              <a:ext cx="77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PKG1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251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Rectangle 70"/>
            <p:cNvSpPr/>
            <p:nvPr/>
          </p:nvSpPr>
          <p:spPr>
            <a:xfrm>
              <a:off x="387360" y="2173320"/>
              <a:ext cx="77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PKG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-115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71"/>
            <p:cNvSpPr/>
            <p:nvPr/>
          </p:nvSpPr>
          <p:spPr>
            <a:xfrm>
              <a:off x="390600" y="2387880"/>
              <a:ext cx="779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900" spc="-1" strike="noStrike">
                  <a:solidFill>
                    <a:srgbClr val="000000"/>
                  </a:solidFill>
                  <a:latin typeface="Arial"/>
                </a:rPr>
                <a:t>PKG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-263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Rectangle 72"/>
            <p:cNvSpPr/>
            <p:nvPr/>
          </p:nvSpPr>
          <p:spPr>
            <a:xfrm>
              <a:off x="393120" y="2597400"/>
              <a:ext cx="813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GSK3β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14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Rectangle 73"/>
            <p:cNvSpPr/>
            <p:nvPr/>
          </p:nvSpPr>
          <p:spPr>
            <a:xfrm>
              <a:off x="393480" y="2816640"/>
              <a:ext cx="8773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GSK3β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-160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Rectangle 74"/>
            <p:cNvSpPr/>
            <p:nvPr/>
          </p:nvSpPr>
          <p:spPr>
            <a:xfrm>
              <a:off x="1899360" y="1247400"/>
              <a:ext cx="1192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</a:rPr>
                <a:t>SiRNA</a:t>
              </a:r>
              <a:r>
                <a:rPr b="1" lang="zh-CN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1" lang="en-US" sz="1000" spc="-1" strike="noStrike">
                  <a:solidFill>
                    <a:srgbClr val="000000"/>
                  </a:solidFill>
                  <a:latin typeface="Arial"/>
                </a:rPr>
                <a:t>sequenc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76"/>
            <p:cNvSpPr/>
            <p:nvPr/>
          </p:nvSpPr>
          <p:spPr>
            <a:xfrm>
              <a:off x="1332000" y="1522080"/>
              <a:ext cx="217872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UUCUCCGAACGUGUCACGUTT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Rectangle 78"/>
            <p:cNvSpPr/>
            <p:nvPr/>
          </p:nvSpPr>
          <p:spPr>
            <a:xfrm>
              <a:off x="1336320" y="1734840"/>
              <a:ext cx="23432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GAGGUUCGUUUGAAGAUUCUATT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80"/>
            <p:cNvSpPr/>
            <p:nvPr/>
          </p:nvSpPr>
          <p:spPr>
            <a:xfrm>
              <a:off x="1348200" y="1949400"/>
              <a:ext cx="230688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UAGAUUACUAUGGUACAGAAATT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Rectangle 84"/>
            <p:cNvSpPr/>
            <p:nvPr/>
          </p:nvSpPr>
          <p:spPr>
            <a:xfrm>
              <a:off x="1356840" y="2387880"/>
              <a:ext cx="22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UUGAGUACUACUAACGUUUAATT-3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Rectangle 86"/>
            <p:cNvSpPr/>
            <p:nvPr/>
          </p:nvSpPr>
          <p:spPr>
            <a:xfrm>
              <a:off x="1354680" y="2597400"/>
              <a:ext cx="22809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CUGCAUUUAUCGUUAACCUAATT-3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88"/>
            <p:cNvSpPr/>
            <p:nvPr/>
          </p:nvSpPr>
          <p:spPr>
            <a:xfrm>
              <a:off x="1364040" y="2816640"/>
              <a:ext cx="227484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CACGUUUGGAAAGAAUAUUAATT-3’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Rectangle 84"/>
            <p:cNvSpPr/>
            <p:nvPr/>
          </p:nvSpPr>
          <p:spPr>
            <a:xfrm>
              <a:off x="1344240" y="2173320"/>
              <a:ext cx="23187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’-CUGGUUAUAGAUCGAGAAACATT-3’</a:t>
              </a:r>
              <a:r>
                <a:rPr b="0" lang="zh-CN" sz="9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Line 66"/>
            <p:cNvSpPr/>
            <p:nvPr/>
          </p:nvSpPr>
          <p:spPr>
            <a:xfrm>
              <a:off x="393480" y="1221840"/>
              <a:ext cx="0" cy="18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Line 66"/>
            <p:cNvSpPr/>
            <p:nvPr/>
          </p:nvSpPr>
          <p:spPr>
            <a:xfrm>
              <a:off x="1333440" y="1221840"/>
              <a:ext cx="0" cy="18367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7"/>
            <p:cNvSpPr/>
            <p:nvPr/>
          </p:nvSpPr>
          <p:spPr>
            <a:xfrm>
              <a:off x="402480" y="1248840"/>
              <a:ext cx="927360" cy="231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Targete</a:t>
              </a:r>
              <a:r>
                <a:rPr b="1" lang="zh-CN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 </a:t>
              </a:r>
              <a:r>
                <a:rPr b="1" lang="en-US" sz="900" spc="-1" strike="noStrike">
                  <a:solidFill>
                    <a:srgbClr val="000000"/>
                  </a:solidFill>
                  <a:latin typeface="Arial"/>
                  <a:ea typeface="宋体"/>
                </a:rPr>
                <a:t>gene 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Line 66"/>
            <p:cNvSpPr/>
            <p:nvPr/>
          </p:nvSpPr>
          <p:spPr>
            <a:xfrm>
              <a:off x="3658320" y="1218600"/>
              <a:ext cx="0" cy="182520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Line 64"/>
            <p:cNvSpPr/>
            <p:nvPr/>
          </p:nvSpPr>
          <p:spPr>
            <a:xfrm>
              <a:off x="390240" y="1736640"/>
              <a:ext cx="327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Line 64"/>
            <p:cNvSpPr/>
            <p:nvPr/>
          </p:nvSpPr>
          <p:spPr>
            <a:xfrm>
              <a:off x="377640" y="2829240"/>
              <a:ext cx="327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Line 64"/>
            <p:cNvSpPr/>
            <p:nvPr/>
          </p:nvSpPr>
          <p:spPr>
            <a:xfrm>
              <a:off x="390240" y="2610720"/>
              <a:ext cx="327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Line 64"/>
            <p:cNvSpPr/>
            <p:nvPr/>
          </p:nvSpPr>
          <p:spPr>
            <a:xfrm>
              <a:off x="390240" y="1955160"/>
              <a:ext cx="327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Line 64"/>
            <p:cNvSpPr/>
            <p:nvPr/>
          </p:nvSpPr>
          <p:spPr>
            <a:xfrm>
              <a:off x="390240" y="2173680"/>
              <a:ext cx="327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Line 64"/>
            <p:cNvSpPr/>
            <p:nvPr/>
          </p:nvSpPr>
          <p:spPr>
            <a:xfrm>
              <a:off x="390240" y="2392200"/>
              <a:ext cx="32767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Line 65"/>
            <p:cNvSpPr/>
            <p:nvPr/>
          </p:nvSpPr>
          <p:spPr>
            <a:xfrm>
              <a:off x="396720" y="1219320"/>
              <a:ext cx="325800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71"/>
            <p:cNvSpPr/>
            <p:nvPr/>
          </p:nvSpPr>
          <p:spPr>
            <a:xfrm>
              <a:off x="350280" y="3791520"/>
              <a:ext cx="4129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pplementary Table 2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Listing of primers used for qPCR in this stud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矩形 72"/>
            <p:cNvSpPr/>
            <p:nvPr/>
          </p:nvSpPr>
          <p:spPr>
            <a:xfrm>
              <a:off x="295200" y="928800"/>
              <a:ext cx="3981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upplementary Table 1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equences of siRNA used in this study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3-01T14:00:44Z</dcterms:created>
  <dc:creator>xiwu</dc:creator>
  <dc:description/>
  <dc:language>en-US</dc:language>
  <cp:lastModifiedBy>Windows 用户</cp:lastModifiedBy>
  <dcterms:modified xsi:type="dcterms:W3CDTF">2014-06-19T13:24:22Z</dcterms:modified>
  <cp:revision>449</cp:revision>
  <dc:subject/>
  <dc:title>幻灯片 1</dc:title>
</cp:coreProperties>
</file>